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9144000" cy="6858000" type="screen4x3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0505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2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755576" y="908720"/>
            <a:ext cx="799288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According to an investigation from our university student, the minimal first-job salary for living in Hangzhou is 2800 RMB/month, most likely first-job salary is 4600 RMB/month, and the desired salary is 6500 RMB/month in Hangzhou.</a:t>
            </a:r>
            <a:endParaRPr lang="zh-CN" altLang="zh-CN" sz="2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 </a:t>
            </a:r>
            <a:endParaRPr lang="zh-CN" altLang="zh-CN" sz="2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2400" dirty="0" smtClean="0">
                <a:latin typeface="Times New Roman" pitchFamily="18" charset="0"/>
                <a:cs typeface="Times New Roman" pitchFamily="18" charset="0"/>
              </a:rPr>
              <a:t>(Note that these sentences were only presented in Experiment 2)</a:t>
            </a:r>
            <a:endParaRPr lang="zh-CN" altLang="en-US" sz="2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619672" y="3691710"/>
          <a:ext cx="6480720" cy="1090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80120"/>
                <a:gridCol w="1080120"/>
                <a:gridCol w="1080120"/>
                <a:gridCol w="1080120"/>
                <a:gridCol w="1080120"/>
                <a:gridCol w="1080120"/>
              </a:tblGrid>
              <a:tr h="1090920"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19" name="矩形 18"/>
          <p:cNvSpPr/>
          <p:nvPr/>
        </p:nvSpPr>
        <p:spPr>
          <a:xfrm>
            <a:off x="827584" y="3645024"/>
            <a:ext cx="8136904" cy="9864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539552" y="4051750"/>
            <a:ext cx="22322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Totally Unfair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08304" y="4051750"/>
            <a:ext cx="15841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Totally Fair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62640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526280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89984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08132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845028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6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781388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915596" y="4901098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55576" y="404664"/>
            <a:ext cx="799288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Please consider the following situation</a:t>
            </a: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Imagine you’re about to graduate. You have received a job offer from a local company in Hangzhou. The salary is A RMB/month. You have also found that another graduating student (same gender) from the same university with similar skills, education background, and other aspects was also received a job offer. His/her salary is B RMB/month.</a:t>
            </a: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ow fair do you think the job offer is? (Please choose number from 1–7)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11560" y="5733256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(Note that A was 2200, 3700, 5100, or 7400 RMB for different conditions. B was equal to A or a random number that higher/lower than A with the absolute difference between 200–400 for different conditions) 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1619672" y="1916832"/>
          <a:ext cx="6480720" cy="1090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80120"/>
                <a:gridCol w="1080120"/>
                <a:gridCol w="1080120"/>
                <a:gridCol w="1080120"/>
                <a:gridCol w="1080120"/>
                <a:gridCol w="1080120"/>
              </a:tblGrid>
              <a:tr h="1090920"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CN" altLang="en-US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矩形 4"/>
          <p:cNvSpPr/>
          <p:nvPr/>
        </p:nvSpPr>
        <p:spPr>
          <a:xfrm>
            <a:off x="827584" y="1340768"/>
            <a:ext cx="7848872" cy="15121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TextBox 5"/>
          <p:cNvSpPr txBox="1"/>
          <p:nvPr/>
        </p:nvSpPr>
        <p:spPr>
          <a:xfrm>
            <a:off x="539552" y="2060848"/>
            <a:ext cx="20162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Totally Unsatisfied 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308304" y="2060848"/>
            <a:ext cx="158417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Totally Satisfied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62640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526280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2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89984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4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08132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3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845028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6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781388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5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915596" y="3126220"/>
            <a:ext cx="3600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 smtClean="0">
                <a:latin typeface="Times New Roman" pitchFamily="18" charset="0"/>
                <a:cs typeface="Times New Roman" pitchFamily="18" charset="0"/>
              </a:rPr>
              <a:t>7</a:t>
            </a:r>
            <a:endParaRPr lang="zh-CN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55576" y="764704"/>
            <a:ext cx="7992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ow satisfied are you about the job offer? (Please choose number from 1–7)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205</Words>
  <Application>Microsoft Office PowerPoint</Application>
  <PresentationFormat>全屏显示(4:3)</PresentationFormat>
  <Paragraphs>33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ray</dc:creator>
  <cp:lastModifiedBy>ray</cp:lastModifiedBy>
  <cp:revision>18</cp:revision>
  <dcterms:created xsi:type="dcterms:W3CDTF">2016-03-27T15:29:35Z</dcterms:created>
  <dcterms:modified xsi:type="dcterms:W3CDTF">2018-02-12T08:46:00Z</dcterms:modified>
</cp:coreProperties>
</file>